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18" d="100"/>
          <a:sy n="118" d="100"/>
        </p:scale>
        <p:origin x="2376" y="2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2/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500" dirty="0"/>
              <a:t>Determinants of 18F-NaF uptake in Femoral Arteries in Patients with type 2 Diabetes Mellitus 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371600" y="2562961"/>
            <a:ext cx="6400800" cy="139110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>
              <a:spcBef>
                <a:spcPts val="0"/>
              </a:spcBef>
            </a:pPr>
            <a:r>
              <a:rPr lang="en-US" altLang="en-US" sz="1200" dirty="0"/>
              <a:t>Richard A.P. </a:t>
            </a:r>
            <a:r>
              <a:rPr lang="en-US" altLang="en-US" sz="1200" dirty="0" err="1"/>
              <a:t>Takx</a:t>
            </a:r>
            <a:r>
              <a:rPr lang="en-US" altLang="en-US" sz="1200" dirty="0"/>
              <a:t> MD MSc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Ruth van Asperen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Jonas W. Bartstra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Sabine R. </a:t>
            </a:r>
            <a:r>
              <a:rPr lang="en-US" altLang="en-US" sz="1200" dirty="0" err="1"/>
              <a:t>Zwakenberg</a:t>
            </a:r>
            <a:r>
              <a:rPr lang="en-US" altLang="en-US" sz="1200" dirty="0"/>
              <a:t> PhD</a:t>
            </a:r>
            <a:r>
              <a:rPr lang="en-US" altLang="en-US" sz="1200" baseline="30000" dirty="0"/>
              <a:t>2</a:t>
            </a:r>
            <a:r>
              <a:rPr lang="en-US" altLang="en-US" sz="1200" dirty="0"/>
              <a:t>, </a:t>
            </a:r>
            <a:r>
              <a:rPr lang="en-US" altLang="en-US" sz="1200" dirty="0" err="1"/>
              <a:t>Jelmer</a:t>
            </a:r>
            <a:r>
              <a:rPr lang="en-US" altLang="en-US" sz="1200" dirty="0"/>
              <a:t> M. </a:t>
            </a:r>
            <a:r>
              <a:rPr lang="en-US" altLang="en-US" sz="1200" dirty="0" err="1"/>
              <a:t>Wolterink</a:t>
            </a:r>
            <a:r>
              <a:rPr lang="en-US" altLang="en-US" sz="1200" dirty="0"/>
              <a:t> PhD</a:t>
            </a:r>
            <a:r>
              <a:rPr lang="en-US" altLang="en-US" sz="1200" baseline="30000" dirty="0"/>
              <a:t>3</a:t>
            </a:r>
            <a:r>
              <a:rPr lang="en-US" altLang="en-US" sz="1200" dirty="0"/>
              <a:t>, </a:t>
            </a:r>
            <a:r>
              <a:rPr lang="en-US" altLang="en-US" sz="1200" dirty="0" err="1"/>
              <a:t>Csilla</a:t>
            </a:r>
            <a:r>
              <a:rPr lang="en-US" altLang="en-US" sz="1200" dirty="0"/>
              <a:t> </a:t>
            </a:r>
            <a:r>
              <a:rPr lang="en-US" altLang="en-US" sz="1200" dirty="0" err="1"/>
              <a:t>Celeng</a:t>
            </a:r>
            <a:r>
              <a:rPr lang="en-US" altLang="en-US" sz="1200" dirty="0"/>
              <a:t> MD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</a:t>
            </a:r>
            <a:r>
              <a:rPr lang="en-US" altLang="en-US" sz="1200" dirty="0" err="1"/>
              <a:t>Pim</a:t>
            </a:r>
            <a:r>
              <a:rPr lang="en-US" altLang="en-US" sz="1200" dirty="0"/>
              <a:t> A. de Jong MD PhD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Joline W. </a:t>
            </a:r>
            <a:r>
              <a:rPr lang="en-US" altLang="en-US" sz="1200" dirty="0" err="1"/>
              <a:t>Beulens</a:t>
            </a:r>
            <a:r>
              <a:rPr lang="en-US" altLang="en-US" sz="1200" dirty="0"/>
              <a:t> PhD</a:t>
            </a:r>
            <a:r>
              <a:rPr lang="en-US" altLang="en-US" sz="1200" baseline="30000" dirty="0"/>
              <a:t>4</a:t>
            </a:r>
            <a:r>
              <a:rPr lang="en-US" altLang="en-US" sz="1200" dirty="0"/>
              <a:t>       </a:t>
            </a:r>
          </a:p>
          <a:p>
            <a:pPr marL="0" lvl="1">
              <a:spcBef>
                <a:spcPts val="0"/>
              </a:spcBef>
            </a:pPr>
            <a:r>
              <a:rPr lang="en-US" altLang="en-US" sz="900" dirty="0"/>
              <a:t>1 Department of Radiology, University Medical Center Utrecht, Utrecht, The Netherlands. </a:t>
            </a:r>
          </a:p>
          <a:p>
            <a:pPr marL="0" lvl="1">
              <a:spcBef>
                <a:spcPts val="0"/>
              </a:spcBef>
            </a:pPr>
            <a:r>
              <a:rPr lang="en-US" altLang="en-US" sz="900" dirty="0"/>
              <a:t> 2 Julius Center for Health Sciences and Primary Care, University Medical Center Utrecht, Utrecht, the Netherlands.  </a:t>
            </a:r>
          </a:p>
          <a:p>
            <a:pPr marL="0" lvl="1">
              <a:spcBef>
                <a:spcPts val="0"/>
              </a:spcBef>
            </a:pPr>
            <a:r>
              <a:rPr lang="en-US" altLang="en-US" sz="900" dirty="0"/>
              <a:t>3 Image Sciences Institute, University Medical Center Utrecht, The Netherlands  </a:t>
            </a:r>
          </a:p>
          <a:p>
            <a:pPr marL="0" lvl="1">
              <a:spcBef>
                <a:spcPts val="0"/>
              </a:spcBef>
            </a:pPr>
            <a:r>
              <a:rPr lang="en-US" altLang="en-US" sz="900" dirty="0"/>
              <a:t>4 Department of Epidemiology &amp; Biostatistics, Amsterdam Public Health Research Institute, Vrije Universiteit, University Medical Center, Amsterdam, the Netherlands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88B5A32-D369-2A4B-992C-FB7E075EBDD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4480" y="4192603"/>
            <a:ext cx="1188720" cy="1522397"/>
          </a:xfrm>
          <a:prstGeom prst="rect">
            <a:avLst/>
          </a:prstGeom>
        </p:spPr>
      </p:pic>
      <p:pic>
        <p:nvPicPr>
          <p:cNvPr id="13" name="Picture 2" descr="Afbeeldingsresultaat voor umc utrecht logo">
            <a:extLst>
              <a:ext uri="{FF2B5EF4-FFF2-40B4-BE49-F238E27FC236}">
                <a16:creationId xmlns:a16="http://schemas.microsoft.com/office/drawing/2014/main" id="{40507680-C7D7-4241-B7F9-16556B199F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3100" y="4163162"/>
            <a:ext cx="1752600" cy="15308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en-NL" sz="2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 allows to identify macrocalcifications of over 200 </a:t>
            </a:r>
            <a:r>
              <a:rPr lang="en-US" altLang="en-NL" sz="28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µ</a:t>
            </a:r>
            <a:r>
              <a:rPr lang="en-US" altLang="en-NL" sz="2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 in diameter.</a:t>
            </a:r>
          </a:p>
          <a:p>
            <a:pPr marL="0" indent="0">
              <a:buNone/>
            </a:pPr>
            <a:r>
              <a:rPr lang="en-US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2- </a:t>
            </a:r>
            <a:r>
              <a:rPr lang="en-US" altLang="en-NL" sz="2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dium 18F-fluoride (</a:t>
            </a:r>
            <a:r>
              <a:rPr lang="en-US" altLang="en-NL" sz="28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8</a:t>
            </a:r>
            <a:r>
              <a:rPr lang="en-US" altLang="en-NL" sz="2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-NaF) PET/CT is a novel imaging technique that can visualize smaller calcifications.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NL" sz="2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- While the use of </a:t>
            </a:r>
            <a:r>
              <a:rPr lang="en-US" altLang="en-NL" sz="28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8</a:t>
            </a:r>
            <a:r>
              <a:rPr lang="en-US" altLang="en-NL" sz="2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-NaF is increasing the available data is limited regarding its uptake values and potential uptake modifiers in high cardiovascular risk groups such as diabetes patients. </a:t>
            </a:r>
          </a:p>
          <a:p>
            <a:pPr marL="0" indent="0">
              <a:buNone/>
            </a:pPr>
            <a:endParaRPr lang="en-US" altLang="en-NL" sz="2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000" dirty="0"/>
              <a:t>Prospective/randomized/double blind/placebo controlled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Inclusion criteria were age &gt;40 years with type 2 diabetes and documented presence of cardiovascular disease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400" dirty="0"/>
              <a:t>Primary end point(s): </a:t>
            </a:r>
            <a:r>
              <a:rPr lang="en-US" altLang="en-US" sz="2000" dirty="0"/>
              <a:t>The relationship between 18F-NaF uptake and calcification on C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</a:t>
            </a:r>
          </a:p>
          <a:p>
            <a:pPr marL="400050" lvl="1" indent="0">
              <a:buNone/>
            </a:pPr>
            <a:r>
              <a:rPr lang="en-US" altLang="en-US" sz="2000" dirty="0"/>
              <a:t>TBR, medication, smoking history, height, weight and blood pressure, cholesterol levels, HbA1c levels and creatinine</a:t>
            </a:r>
            <a:r>
              <a:rPr lang="en-US" altLang="en-US" sz="1400" dirty="0"/>
              <a:t>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Content Placeholder 8">
            <a:extLst>
              <a:ext uri="{FF2B5EF4-FFF2-40B4-BE49-F238E27FC236}">
                <a16:creationId xmlns:a16="http://schemas.microsoft.com/office/drawing/2014/main" id="{CE22E14E-622C-DA44-A5E8-98D2829ABA4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25206810"/>
              </p:ext>
            </p:extLst>
          </p:nvPr>
        </p:nvGraphicFramePr>
        <p:xfrm>
          <a:off x="723901" y="1744767"/>
          <a:ext cx="7696198" cy="420779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850847">
                  <a:extLst>
                    <a:ext uri="{9D8B030D-6E8A-4147-A177-3AD203B41FA5}">
                      <a16:colId xmlns:a16="http://schemas.microsoft.com/office/drawing/2014/main" val="2251570515"/>
                    </a:ext>
                  </a:extLst>
                </a:gridCol>
                <a:gridCol w="1412935">
                  <a:extLst>
                    <a:ext uri="{9D8B030D-6E8A-4147-A177-3AD203B41FA5}">
                      <a16:colId xmlns:a16="http://schemas.microsoft.com/office/drawing/2014/main" val="3587278905"/>
                    </a:ext>
                  </a:extLst>
                </a:gridCol>
                <a:gridCol w="978906">
                  <a:extLst>
                    <a:ext uri="{9D8B030D-6E8A-4147-A177-3AD203B41FA5}">
                      <a16:colId xmlns:a16="http://schemas.microsoft.com/office/drawing/2014/main" val="1957938814"/>
                    </a:ext>
                  </a:extLst>
                </a:gridCol>
                <a:gridCol w="1282570">
                  <a:extLst>
                    <a:ext uri="{9D8B030D-6E8A-4147-A177-3AD203B41FA5}">
                      <a16:colId xmlns:a16="http://schemas.microsoft.com/office/drawing/2014/main" val="3144137777"/>
                    </a:ext>
                  </a:extLst>
                </a:gridCol>
                <a:gridCol w="1170940">
                  <a:extLst>
                    <a:ext uri="{9D8B030D-6E8A-4147-A177-3AD203B41FA5}">
                      <a16:colId xmlns:a16="http://schemas.microsoft.com/office/drawing/2014/main" val="2148972740"/>
                    </a:ext>
                  </a:extLst>
                </a:gridCol>
              </a:tblGrid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linical characteristics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Univariate</a:t>
                      </a:r>
                      <a:endParaRPr lang="en-NL" sz="6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β (95% CI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-value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ulti-variate</a:t>
                      </a:r>
                      <a:endParaRPr lang="en-NL" sz="6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β (95% CI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-value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318928315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ge (years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5 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15-0.025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614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A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480004877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Female sex</a:t>
                      </a:r>
                      <a:endParaRPr lang="en-NL" sz="6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25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428-0.349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838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A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4195333489"/>
                  </a:ext>
                </a:extLst>
              </a:tr>
              <a:tr h="9223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lood pressure 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85896560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Systolic (mmHg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02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12-0.007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644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03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13-0.007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516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335176155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Diastolic (mmHg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10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26-0.005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89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10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27-0.007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229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1357940127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ody mass index (kg/m</a:t>
                      </a:r>
                      <a:r>
                        <a:rPr lang="en-US" sz="600" baseline="30000">
                          <a:effectLst/>
                        </a:rPr>
                        <a:t>2</a:t>
                      </a:r>
                      <a:r>
                        <a:rPr lang="en-US" sz="600">
                          <a:effectLst/>
                        </a:rPr>
                        <a:t>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9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12-0.05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222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26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08-0.06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27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820661060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Femoral calcium mass by CT*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349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204-0.494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&lt;0.001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417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251-0.582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&lt;0.001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4062824516"/>
                  </a:ext>
                </a:extLst>
              </a:tr>
              <a:tr h="9223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holesterol 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97458788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Total (mmol/l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59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034-0.284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3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68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040-0.296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1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540619840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LDL (mmol/l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11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71-0.292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227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20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69-0.308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210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848323899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 dirty="0">
                          <a:effectLst/>
                        </a:rPr>
                        <a:t>HDL (mmol/l)</a:t>
                      </a:r>
                      <a:endParaRPr lang="en-NL" sz="6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12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626-0.602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969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45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706-0.616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891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371684198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riglycerides (mmol/l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44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03-0.09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64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48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000-0.095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52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1097345534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HbA1c (mmol/mol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1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000-0.021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42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4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0.003-0.025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5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044979430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erum creatinine (</a:t>
                      </a:r>
                      <a:r>
                        <a:rPr lang="en-US" sz="600">
                          <a:effectLst/>
                          <a:sym typeface="Symbol" pitchFamily="2" charset="2"/>
                        </a:rPr>
                        <a:t></a:t>
                      </a:r>
                      <a:r>
                        <a:rPr lang="en-US" sz="600">
                          <a:effectLst/>
                        </a:rPr>
                        <a:t>mol/l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01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06-0.008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847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00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08-0.008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965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261236413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urrent Smokers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42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507-0.424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858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030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504-0.444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900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786537967"/>
                  </a:ext>
                </a:extLst>
              </a:tr>
              <a:tr h="14290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edication use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309851373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Insulin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245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80-0.57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37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283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056-0.622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100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3056443013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Statins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349</a:t>
                      </a:r>
                      <a:endParaRPr lang="en-NL" sz="6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(-0.728-0.03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70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237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762-0.014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58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096923280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Glucose lowering drugs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199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708-0.311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439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268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812-0.276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329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487904385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Lipid lowering drugs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09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322-0.34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957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014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323-0.350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934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2967261042"/>
                  </a:ext>
                </a:extLst>
              </a:tr>
              <a:tr h="19084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Calibri" panose="020F0502020204030204" pitchFamily="34" charset="0"/>
                        <a:buChar char="-"/>
                      </a:pPr>
                      <a:r>
                        <a:rPr lang="en-US" sz="600">
                          <a:effectLst/>
                        </a:rPr>
                        <a:t>Antihypertensive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146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656-0.365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.571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.136</a:t>
                      </a:r>
                      <a:br>
                        <a:rPr lang="en-US" sz="600">
                          <a:effectLst/>
                        </a:rPr>
                      </a:br>
                      <a:r>
                        <a:rPr lang="en-US" sz="600">
                          <a:effectLst/>
                        </a:rPr>
                        <a:t>(-0.656-0.385)</a:t>
                      </a:r>
                      <a:endParaRPr lang="en-NL" sz="6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0.605</a:t>
                      </a:r>
                      <a:endParaRPr lang="en-NL" sz="6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077" marR="35077" marT="0" marB="0"/>
                </a:tc>
                <a:extLst>
                  <a:ext uri="{0D108BD9-81ED-4DB2-BD59-A6C34878D82A}">
                    <a16:rowId xmlns:a16="http://schemas.microsoft.com/office/drawing/2014/main" val="1347001596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827441EA-98E7-E745-A872-112C6AA382DD}"/>
              </a:ext>
            </a:extLst>
          </p:cNvPr>
          <p:cNvSpPr txBox="1"/>
          <p:nvPr/>
        </p:nvSpPr>
        <p:spPr>
          <a:xfrm>
            <a:off x="723901" y="5986739"/>
            <a:ext cx="727652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Multivariate linear regression age and sex adjusted. </a:t>
            </a:r>
            <a:r>
              <a:rPr lang="el-GR" sz="1000" dirty="0"/>
              <a:t>β </a:t>
            </a:r>
            <a:r>
              <a:rPr lang="en-GB" sz="1000" dirty="0"/>
              <a:t>is per one unit change. </a:t>
            </a:r>
          </a:p>
          <a:p>
            <a:r>
              <a:rPr lang="en-GB" sz="1000" dirty="0"/>
              <a:t>* log (coronary calcium score plus 1)</a:t>
            </a:r>
          </a:p>
          <a:p>
            <a:endParaRPr lang="en-NL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7A1FBEE-F36E-A64D-8779-E333BDE68BF0}"/>
              </a:ext>
            </a:extLst>
          </p:cNvPr>
          <p:cNvSpPr txBox="1"/>
          <p:nvPr/>
        </p:nvSpPr>
        <p:spPr>
          <a:xfrm>
            <a:off x="691309" y="1363348"/>
            <a:ext cx="41344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Uni- and multivariate linear regression </a:t>
            </a:r>
          </a:p>
          <a:p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08CC59A-55D6-8E4B-B569-70C37768056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600" y="1393062"/>
            <a:ext cx="7162800" cy="40332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E4F0CF-4E46-4444-8AA5-C3FCDA8D0AF9}"/>
              </a:ext>
            </a:extLst>
          </p:cNvPr>
          <p:cNvSpPr txBox="1"/>
          <p:nvPr/>
        </p:nvSpPr>
        <p:spPr>
          <a:xfrm>
            <a:off x="891268" y="5570512"/>
            <a:ext cx="66525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xial CT image (A) showing circular calcification in the superficial femoral artery and fusion image (B) with a circular region </a:t>
            </a:r>
            <a:r>
              <a:rPr lang="en-US" sz="1000"/>
              <a:t>of interest (ROI) </a:t>
            </a:r>
            <a:r>
              <a:rPr lang="en-US" sz="1000" dirty="0"/>
              <a:t>drawn for quantification 18F-NaF </a:t>
            </a:r>
            <a:r>
              <a:rPr lang="en-US" sz="1000" dirty="0" err="1"/>
              <a:t>SUVmax</a:t>
            </a:r>
            <a:r>
              <a:rPr lang="en-US" sz="1000" dirty="0"/>
              <a:t> in the femoral artery. Axial fusion image (C) demonstrating background measurement of </a:t>
            </a:r>
            <a:r>
              <a:rPr lang="en-US" sz="1000" dirty="0" err="1"/>
              <a:t>SUVmean</a:t>
            </a:r>
            <a:r>
              <a:rPr lang="en-US" sz="1000" dirty="0"/>
              <a:t> in the superior vena cava using a circular ROI. </a:t>
            </a:r>
          </a:p>
          <a:p>
            <a:endParaRPr lang="en-NL" sz="10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Cardiovascular risk factors including total cholesterol, triglycerides and HbA1c are associated with 18F-NaF uptake and calcification in the femoral arteries in patients with type 2 diabetes mellitus and a history of arterial disease. </a:t>
            </a:r>
          </a:p>
          <a:p>
            <a:pPr marL="0" indent="0">
              <a:buNone/>
            </a:pPr>
            <a:r>
              <a:rPr lang="en-US" altLang="en-US" sz="2800" dirty="0"/>
              <a:t>2- Our findings show that 18F-NaF uptake can be an imaging biomarker of arterial disease burden both related to dyslipidemia and diabetes control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</TotalTime>
  <Words>885</Words>
  <Application>Microsoft Macintosh PowerPoint</Application>
  <PresentationFormat>On-screen Show (4:3)</PresentationFormat>
  <Paragraphs>15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SsykbnAdvPTimes</vt:lpstr>
      <vt:lpstr>Symbol</vt:lpstr>
      <vt:lpstr>Times New Roman</vt:lpstr>
      <vt:lpstr>2_Office Theme</vt:lpstr>
      <vt:lpstr>Custom Design</vt:lpstr>
      <vt:lpstr>1_Custom Design</vt:lpstr>
      <vt:lpstr>Determinants of 18F-NaF uptake in Femoral Arteries in Patients with type 2 Diabetes Mellitus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ichard Takx</cp:lastModifiedBy>
  <cp:revision>119</cp:revision>
  <dcterms:created xsi:type="dcterms:W3CDTF">2011-04-18T21:44:13Z</dcterms:created>
  <dcterms:modified xsi:type="dcterms:W3CDTF">2020-02-02T16:53:17Z</dcterms:modified>
</cp:coreProperties>
</file>